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  <p:sldId id="256" r:id="rId3"/>
    <p:sldId id="257" r:id="rId4"/>
    <p:sldId id="258" r:id="rId5"/>
    <p:sldId id="259" r:id="rId6"/>
    <p:sldId id="260" r:id="rId7"/>
    <p:sldId id="261" r:id="rId8"/>
    <p:sldId id="262" r:id="rId9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91" d="100"/>
          <a:sy n="91" d="100"/>
        </p:scale>
        <p:origin x="370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8539-D942-4CCF-916D-5A4BD29B46D7}" type="datetimeFigureOut">
              <a:rPr lang="en-NZ" smtClean="0"/>
              <a:t>2/11/2018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8BC1ED-8084-48E4-83F0-D39E768EE56F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7868539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8539-D942-4CCF-916D-5A4BD29B46D7}" type="datetimeFigureOut">
              <a:rPr lang="en-NZ" smtClean="0"/>
              <a:t>2/11/2018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8BC1ED-8084-48E4-83F0-D39E768EE56F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0754658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8539-D942-4CCF-916D-5A4BD29B46D7}" type="datetimeFigureOut">
              <a:rPr lang="en-NZ" smtClean="0"/>
              <a:t>2/11/2018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8BC1ED-8084-48E4-83F0-D39E768EE56F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4898555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8539-D942-4CCF-916D-5A4BD29B46D7}" type="datetimeFigureOut">
              <a:rPr lang="en-NZ" smtClean="0"/>
              <a:t>2/11/2018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8BC1ED-8084-48E4-83F0-D39E768EE56F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4288126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8539-D942-4CCF-916D-5A4BD29B46D7}" type="datetimeFigureOut">
              <a:rPr lang="en-NZ" smtClean="0"/>
              <a:t>2/11/2018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8BC1ED-8084-48E4-83F0-D39E768EE56F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4088279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8539-D942-4CCF-916D-5A4BD29B46D7}" type="datetimeFigureOut">
              <a:rPr lang="en-NZ" smtClean="0"/>
              <a:t>2/11/2018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8BC1ED-8084-48E4-83F0-D39E768EE56F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6483036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8539-D942-4CCF-916D-5A4BD29B46D7}" type="datetimeFigureOut">
              <a:rPr lang="en-NZ" smtClean="0"/>
              <a:t>2/11/2018</a:t>
            </a:fld>
            <a:endParaRPr lang="en-NZ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8BC1ED-8084-48E4-83F0-D39E768EE56F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3683267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8539-D942-4CCF-916D-5A4BD29B46D7}" type="datetimeFigureOut">
              <a:rPr lang="en-NZ" smtClean="0"/>
              <a:t>2/11/2018</a:t>
            </a:fld>
            <a:endParaRPr lang="en-NZ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8BC1ED-8084-48E4-83F0-D39E768EE56F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8410011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8539-D942-4CCF-916D-5A4BD29B46D7}" type="datetimeFigureOut">
              <a:rPr lang="en-NZ" smtClean="0"/>
              <a:t>2/11/2018</a:t>
            </a:fld>
            <a:endParaRPr lang="en-NZ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8BC1ED-8084-48E4-83F0-D39E768EE56F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3597165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8539-D942-4CCF-916D-5A4BD29B46D7}" type="datetimeFigureOut">
              <a:rPr lang="en-NZ" smtClean="0"/>
              <a:t>2/11/2018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8BC1ED-8084-48E4-83F0-D39E768EE56F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9081043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NZ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3738539-D942-4CCF-916D-5A4BD29B46D7}" type="datetimeFigureOut">
              <a:rPr lang="en-NZ" smtClean="0"/>
              <a:t>2/11/2018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8BC1ED-8084-48E4-83F0-D39E768EE56F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3176962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738539-D942-4CCF-916D-5A4BD29B46D7}" type="datetimeFigureOut">
              <a:rPr lang="en-NZ" smtClean="0"/>
              <a:t>2/11/2018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8BC1ED-8084-48E4-83F0-D39E768EE56F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41192508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48425697"/>
              </p:ext>
            </p:extLst>
          </p:nvPr>
        </p:nvGraphicFramePr>
        <p:xfrm>
          <a:off x="1191236" y="2055305"/>
          <a:ext cx="9279914" cy="183089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047238"/>
                <a:gridCol w="2047238"/>
                <a:gridCol w="1723990"/>
                <a:gridCol w="2451298"/>
                <a:gridCol w="1010150"/>
              </a:tblGrid>
              <a:tr h="366179">
                <a:tc>
                  <a:txBody>
                    <a:bodyPr/>
                    <a:lstStyle/>
                    <a:p>
                      <a:pPr algn="ctr" fontAlgn="b"/>
                      <a:r>
                        <a:rPr lang="en-NZ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ummary</a:t>
                      </a:r>
                      <a:endParaRPr lang="en-NZ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NZ" sz="1100" u="none" strike="noStrike">
                          <a:effectLst/>
                        </a:rPr>
                        <a:t>Total number of individuals</a:t>
                      </a:r>
                      <a:endParaRPr lang="en-NZ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NZ" sz="1100" u="none" strike="noStrike">
                          <a:effectLst/>
                        </a:rPr>
                        <a:t>Average phenotype sensory</a:t>
                      </a:r>
                      <a:endParaRPr lang="en-NZ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>
                          <a:effectLst/>
                        </a:rPr>
                        <a:t>Average phenotypes crisp- and firmness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NZ" sz="1100" u="none" strike="noStrike">
                          <a:effectLst/>
                        </a:rPr>
                        <a:t>Backward BLUP</a:t>
                      </a:r>
                      <a:endParaRPr lang="en-NZ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366179">
                <a:tc>
                  <a:txBody>
                    <a:bodyPr/>
                    <a:lstStyle/>
                    <a:p>
                      <a:pPr algn="ctr" fontAlgn="b"/>
                      <a:r>
                        <a:rPr lang="en-NZ" sz="1100" u="none" strike="noStrike">
                          <a:effectLst/>
                        </a:rPr>
                        <a:t>Commercial cultivars</a:t>
                      </a:r>
                      <a:endParaRPr lang="en-NZ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NZ" sz="1100" u="none" strike="noStrike">
                          <a:effectLst/>
                        </a:rPr>
                        <a:t>41</a:t>
                      </a:r>
                      <a:endParaRPr lang="en-NZ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NZ" sz="1100" u="none" strike="noStrike">
                          <a:effectLst/>
                        </a:rPr>
                        <a:t>n/a</a:t>
                      </a:r>
                      <a:endParaRPr lang="en-NZ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NZ" sz="1100" u="none" strike="noStrike">
                          <a:effectLst/>
                        </a:rPr>
                        <a:t>15</a:t>
                      </a:r>
                      <a:endParaRPr lang="en-NZ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NZ" sz="1100" u="none" strike="noStrike">
                          <a:effectLst/>
                        </a:rPr>
                        <a:t>41</a:t>
                      </a:r>
                      <a:endParaRPr lang="en-NZ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366179">
                <a:tc>
                  <a:txBody>
                    <a:bodyPr/>
                    <a:lstStyle/>
                    <a:p>
                      <a:pPr algn="ctr" fontAlgn="b"/>
                      <a:r>
                        <a:rPr lang="en-NZ" sz="1100" u="none" strike="noStrike" dirty="0">
                          <a:effectLst/>
                        </a:rPr>
                        <a:t>PFR </a:t>
                      </a:r>
                      <a:r>
                        <a:rPr lang="en-NZ" sz="1100" u="none" strike="noStrike" dirty="0" smtClean="0">
                          <a:effectLst/>
                        </a:rPr>
                        <a:t>advanced </a:t>
                      </a:r>
                      <a:r>
                        <a:rPr lang="en-NZ" sz="1100" u="none" strike="noStrike" dirty="0">
                          <a:effectLst/>
                        </a:rPr>
                        <a:t>selections</a:t>
                      </a:r>
                      <a:endParaRPr lang="en-NZ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NZ" sz="1100" u="none" strike="noStrike">
                          <a:effectLst/>
                        </a:rPr>
                        <a:t>81</a:t>
                      </a:r>
                      <a:endParaRPr lang="en-NZ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NZ" sz="1100" u="none" strike="noStrike">
                          <a:effectLst/>
                        </a:rPr>
                        <a:t>n/a</a:t>
                      </a:r>
                      <a:endParaRPr lang="en-NZ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NZ" sz="1100" u="none" strike="noStrike">
                          <a:effectLst/>
                        </a:rPr>
                        <a:t>77</a:t>
                      </a:r>
                      <a:endParaRPr lang="en-NZ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NZ" sz="1100" u="none" strike="noStrike">
                          <a:effectLst/>
                        </a:rPr>
                        <a:t>56</a:t>
                      </a:r>
                      <a:endParaRPr lang="en-NZ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366179">
                <a:tc>
                  <a:txBody>
                    <a:bodyPr/>
                    <a:lstStyle/>
                    <a:p>
                      <a:pPr algn="ctr" fontAlgn="b"/>
                      <a:r>
                        <a:rPr lang="en-NZ" sz="1100" u="none" strike="noStrike">
                          <a:effectLst/>
                        </a:rPr>
                        <a:t>Validation families</a:t>
                      </a:r>
                      <a:endParaRPr lang="en-NZ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NZ" sz="1100" u="none" strike="noStrike">
                          <a:effectLst/>
                        </a:rPr>
                        <a:t>65</a:t>
                      </a:r>
                      <a:endParaRPr lang="en-NZ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NZ" sz="1100" u="none" strike="noStrike">
                          <a:effectLst/>
                        </a:rPr>
                        <a:t>65</a:t>
                      </a:r>
                      <a:endParaRPr lang="en-NZ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NZ" sz="1100" u="none" strike="noStrike">
                          <a:effectLst/>
                        </a:rPr>
                        <a:t>n/a</a:t>
                      </a:r>
                      <a:endParaRPr lang="en-NZ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NZ" sz="1100" u="none" strike="noStrike">
                          <a:effectLst/>
                        </a:rPr>
                        <a:t>n/a</a:t>
                      </a:r>
                      <a:endParaRPr lang="en-NZ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  <a:tr h="366179">
                <a:tc>
                  <a:txBody>
                    <a:bodyPr/>
                    <a:lstStyle/>
                    <a:p>
                      <a:pPr algn="ctr" fontAlgn="b"/>
                      <a:r>
                        <a:rPr lang="en-NZ" sz="1100" u="none" strike="noStrike">
                          <a:effectLst/>
                        </a:rPr>
                        <a:t>Mapping populations (resistance)</a:t>
                      </a:r>
                      <a:endParaRPr lang="en-NZ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NZ" sz="1100" u="none" strike="noStrike">
                          <a:effectLst/>
                        </a:rPr>
                        <a:t>20</a:t>
                      </a:r>
                      <a:endParaRPr lang="en-NZ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NZ" sz="1100" u="none" strike="noStrike">
                          <a:effectLst/>
                        </a:rPr>
                        <a:t>n/a</a:t>
                      </a:r>
                      <a:endParaRPr lang="en-NZ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NZ" sz="1100" u="none" strike="noStrike">
                          <a:effectLst/>
                        </a:rPr>
                        <a:t>n/a</a:t>
                      </a:r>
                      <a:endParaRPr lang="en-NZ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NZ" sz="1100" u="none" strike="noStrike" dirty="0">
                          <a:effectLst/>
                        </a:rPr>
                        <a:t>n/a</a:t>
                      </a:r>
                      <a:endParaRPr lang="en-NZ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620" marR="7620" marT="7620" marB="0" anchor="b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95849424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2"/>
          <a:srcRect t="10396"/>
          <a:stretch/>
        </p:blipFill>
        <p:spPr>
          <a:xfrm>
            <a:off x="6340929" y="1149292"/>
            <a:ext cx="5715000" cy="5120880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3"/>
          <a:srcRect t="10396"/>
          <a:stretch/>
        </p:blipFill>
        <p:spPr>
          <a:xfrm>
            <a:off x="625929" y="1149292"/>
            <a:ext cx="5715000" cy="51208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1667979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/>
          <a:srcRect t="10428"/>
          <a:stretch/>
        </p:blipFill>
        <p:spPr>
          <a:xfrm>
            <a:off x="0" y="1216404"/>
            <a:ext cx="5715000" cy="5119082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3"/>
          <a:srcRect t="10122"/>
          <a:stretch/>
        </p:blipFill>
        <p:spPr>
          <a:xfrm>
            <a:off x="6234793" y="1174459"/>
            <a:ext cx="5715000" cy="513653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9257397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/>
          <a:srcRect t="10566"/>
          <a:stretch/>
        </p:blipFill>
        <p:spPr>
          <a:xfrm>
            <a:off x="87086" y="1208015"/>
            <a:ext cx="5715000" cy="5111142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3"/>
          <a:srcRect t="10412"/>
          <a:stretch/>
        </p:blipFill>
        <p:spPr>
          <a:xfrm>
            <a:off x="6136822" y="1182848"/>
            <a:ext cx="5715000" cy="5119980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1451295" y="5645791"/>
            <a:ext cx="3856825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NZ" dirty="0" smtClean="0"/>
              <a:t>Crispness (BLUP – advanced selections)</a:t>
            </a:r>
            <a:endParaRPr lang="en-NZ" dirty="0"/>
          </a:p>
        </p:txBody>
      </p:sp>
    </p:spTree>
    <p:extLst>
      <p:ext uri="{BB962C8B-B14F-4D97-AF65-F5344CB8AC3E}">
        <p14:creationId xmlns:p14="http://schemas.microsoft.com/office/powerpoint/2010/main" val="383280658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/>
          <a:srcRect t="10593"/>
          <a:stretch/>
        </p:blipFill>
        <p:spPr>
          <a:xfrm>
            <a:off x="136072" y="1266737"/>
            <a:ext cx="5715000" cy="5109569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3"/>
          <a:srcRect t="10740"/>
          <a:stretch/>
        </p:blipFill>
        <p:spPr>
          <a:xfrm>
            <a:off x="5777593" y="1275127"/>
            <a:ext cx="5715000" cy="51011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1507805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/>
          <a:srcRect t="9967"/>
          <a:stretch/>
        </p:blipFill>
        <p:spPr>
          <a:xfrm>
            <a:off x="193221" y="1149292"/>
            <a:ext cx="5715000" cy="5145372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3"/>
          <a:srcRect t="11023"/>
          <a:stretch/>
        </p:blipFill>
        <p:spPr>
          <a:xfrm>
            <a:off x="6477000" y="1266738"/>
            <a:ext cx="5715000" cy="508507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9791065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/>
          <a:srcRect t="10776"/>
          <a:stretch/>
        </p:blipFill>
        <p:spPr>
          <a:xfrm>
            <a:off x="315686" y="1350628"/>
            <a:ext cx="5715000" cy="5099158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3"/>
          <a:srcRect t="10629"/>
          <a:stretch/>
        </p:blipFill>
        <p:spPr>
          <a:xfrm>
            <a:off x="5924550" y="1342238"/>
            <a:ext cx="5715000" cy="510754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7906342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410325" y="604157"/>
            <a:ext cx="5429250" cy="5715000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54454" y="522514"/>
            <a:ext cx="5429250" cy="5715000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1763486" y="234825"/>
            <a:ext cx="20952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dirty="0" smtClean="0"/>
              <a:t>Advanced selections</a:t>
            </a:r>
            <a:endParaRPr lang="en-NZ" dirty="0"/>
          </a:p>
        </p:txBody>
      </p:sp>
      <p:sp>
        <p:nvSpPr>
          <p:cNvPr id="8" name="TextBox 7"/>
          <p:cNvSpPr txBox="1"/>
          <p:nvPr/>
        </p:nvSpPr>
        <p:spPr>
          <a:xfrm>
            <a:off x="7941129" y="234825"/>
            <a:ext cx="21375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NZ" dirty="0" smtClean="0"/>
              <a:t>Commercial cultivars</a:t>
            </a:r>
            <a:endParaRPr lang="en-NZ" dirty="0"/>
          </a:p>
        </p:txBody>
      </p:sp>
    </p:spTree>
    <p:extLst>
      <p:ext uri="{BB962C8B-B14F-4D97-AF65-F5344CB8AC3E}">
        <p14:creationId xmlns:p14="http://schemas.microsoft.com/office/powerpoint/2010/main" val="1124899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9</TotalTime>
  <Words>54</Words>
  <Application>Microsoft Office PowerPoint</Application>
  <PresentationFormat>Widescreen</PresentationFormat>
  <Paragraphs>28</Paragraphs>
  <Slides>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2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Plant &amp; Food Research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vid Chagne</dc:creator>
  <cp:lastModifiedBy>David Chagne</cp:lastModifiedBy>
  <cp:revision>6</cp:revision>
  <dcterms:created xsi:type="dcterms:W3CDTF">2018-10-26T03:45:00Z</dcterms:created>
  <dcterms:modified xsi:type="dcterms:W3CDTF">2018-11-02T01:23:23Z</dcterms:modified>
</cp:coreProperties>
</file>